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8F1B35-118A-44A3-A0CB-0D966D1B5D82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EFE02F-77F7-4EF8-B90D-B3FC9DBDF0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1971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61B3D6-F026-43AC-8AAD-10FECBAE76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5339D1C-EC89-454C-9F71-EF0AB265F6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024928-1936-44F1-8589-30897F542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8E1E3B-DF0D-4101-801C-3E3B2BAF6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CD9619-1D1F-4FBF-8E16-DFDC92855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124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187554-CD74-41AF-BCF2-9D5EBE7BBA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22A0C5-A161-4773-A8E5-4FD3984AB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8365C6-8E51-4058-89C8-3D5D4650C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79CB37-0B67-4507-BF9A-294CF3925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4D2C49-5505-4F14-9F68-E0C0BE9B5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528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BEFFBB-3EC3-4ECA-88B1-7D80E6409B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862A88-923E-4A92-A45E-8DB23B9150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171B45-59FF-41FF-9812-9990D84CBB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97B25F-AC0D-4000-8691-D5A40C497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3DEA1E-59BD-4A21-A935-1C3C83DE44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409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0165B3-66AC-4A0B-B99E-F1819C9D6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643DFE-24B3-444A-9F99-246EAE9DCF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4B2F6-9B38-478B-B5AE-1DE84EF74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684608-6074-412E-832B-048B7976B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FC504A-D162-45BD-B599-068FF7B6C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41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6258C-C276-4724-9EBB-A6C5816366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1753A8-3BAB-4A44-8372-36FAE5F9EF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6F8C6C-7C0C-43FC-854B-7F7A74AAB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31E10D-D4E1-47ED-95A5-96CC10551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969EFE-A0A8-4937-A298-9AEC4FC9A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252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6E95DC-5916-4C56-AE3F-A9E8BA2809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301AAB-20AF-48C6-B2E1-31DCC9421D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C019A7-41EB-4E9C-8EB7-5D4F5EEF39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51DDCF-2BAC-4FC1-82E4-32FC3490B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14DB91-6BF7-4E9F-A02E-58E0AEB95A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F01949-2796-4B57-8E24-278212BE8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510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CD4272-7C75-4A53-A3FB-1DC3E9853B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276919-2A1E-4AEF-93B9-7742626AC4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159F84-CA5F-4B3A-8BF8-915921C6FA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4E4908-6C43-4D89-84A0-FF45E7D605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FC1F8BD-984D-465C-9E40-8BF30D9F5F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068878C-5A92-474E-91D3-CB2933618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84D6C81-1562-4220-B573-950495A6C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A26A8C-D1F1-4418-BCB1-A4F9BFCF7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674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B05636-D5A7-4BDB-B859-08A948692B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1F44A54-252E-4DD6-BD50-30810F7EC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B9F855-9F2A-468F-B1D2-47A4BCDD5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A3506DC-ECA4-4D23-95A8-E615E0460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051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EB5ADF0-2307-4F47-857F-030FF110F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C1B0EC0-DD68-4AF7-B197-0750359D4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8F0BAE4-B9CF-4775-BAA4-01FD749BDD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975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FF2002-0340-4F5D-AF8F-CD59B0488A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44A116-95C9-4687-9EFB-9299D3C95E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6A0DE4-5E16-44FA-89BE-6FCC121C1A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C105BA-2130-4D26-8196-018D8D802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9D0BFA-A5B6-483F-8CF4-B3354682E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33BBA9-F054-4B16-84B0-86ED1578B7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310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1EA61A-219F-4E0C-B22B-1DA165C8F1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DCF63A-26EE-445C-A074-17ECF147F0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F16CAB-9E6C-419E-BA45-EE1B64CEA1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686DDA-D0D2-41E4-BABF-BE8686587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E879DB-1A16-4839-8704-CE2E1C2A0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04BFB1-FF2B-42A8-B250-E55492ED27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12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99CF45-A7A7-4D90-BD1E-D28C2CA20D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AD358D-53B8-4332-8777-04C1A84262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50EEE4-CE91-46BA-B608-7F33D6C9B6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F9334-034E-45C2-9846-FFC983D8754A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D0DE82-3596-4833-9214-84FD04A1C7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F6753C-EFAA-4A78-AAE9-408958A8AD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1B5BEF-BBD8-411B-B3FE-CB3639D50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101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9C04B78E-244B-4046-9899-195E3EB3BF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9564929"/>
              </p:ext>
            </p:extLst>
          </p:nvPr>
        </p:nvGraphicFramePr>
        <p:xfrm>
          <a:off x="2360474" y="896645"/>
          <a:ext cx="6419541" cy="540448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39847">
                  <a:extLst>
                    <a:ext uri="{9D8B030D-6E8A-4147-A177-3AD203B41FA5}">
                      <a16:colId xmlns:a16="http://schemas.microsoft.com/office/drawing/2014/main" val="1376733020"/>
                    </a:ext>
                  </a:extLst>
                </a:gridCol>
                <a:gridCol w="2139847">
                  <a:extLst>
                    <a:ext uri="{9D8B030D-6E8A-4147-A177-3AD203B41FA5}">
                      <a16:colId xmlns:a16="http://schemas.microsoft.com/office/drawing/2014/main" val="462021101"/>
                    </a:ext>
                  </a:extLst>
                </a:gridCol>
                <a:gridCol w="2139847">
                  <a:extLst>
                    <a:ext uri="{9D8B030D-6E8A-4147-A177-3AD203B41FA5}">
                      <a16:colId xmlns:a16="http://schemas.microsoft.com/office/drawing/2014/main" val="1459940924"/>
                    </a:ext>
                  </a:extLst>
                </a:gridCol>
              </a:tblGrid>
              <a:tr h="324440">
                <a:tc>
                  <a:txBody>
                    <a:bodyPr/>
                    <a:lstStyle/>
                    <a:p>
                      <a:pPr algn="ctr"/>
                      <a:r>
                        <a:rPr lang="en-AU" dirty="0"/>
                        <a:t>Strategy I</a:t>
                      </a:r>
                      <a:endParaRPr lang="en-US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dirty="0"/>
                        <a:t>Strategy I</a:t>
                      </a:r>
                      <a:r>
                        <a:rPr lang="en-US" dirty="0"/>
                        <a:t>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dirty="0"/>
                        <a:t>Strategy I</a:t>
                      </a:r>
                      <a:r>
                        <a:rPr lang="en-US" dirty="0"/>
                        <a:t>I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9247825"/>
                  </a:ext>
                </a:extLst>
              </a:tr>
              <a:tr h="4469501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orth American beaver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oay</a:t>
                      </a: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sheep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Cheetah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European badger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Meerkat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Raccoon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Lechwe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Pyrenean chamois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Arctic fox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Banded mongoose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American red squirrel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Belding’s ground squirrel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Golden-mantled ground squirrel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Hippopotamus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Eastern gorilla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Brown bear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Blue monkey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teller sea lion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Polar bear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teller sea lion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Hawaiian monk seal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Walrus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Olive baboon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White-headed capuchin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Yellow baboon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orthern fur seal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Australian fur seal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Japanese serow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Plains zebra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American bison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Antarctic fur seal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Bighorn sheep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Himalayan </a:t>
                      </a:r>
                      <a:r>
                        <a:rPr lang="en-US" sz="11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tahr</a:t>
                      </a:r>
                      <a:endParaRPr lang="en-US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Leopard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Moose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Red deer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Weddell seal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Lion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Reindeer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Ring-tailed lemur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Collared peccary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Japanese macaque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Yellow-bellied marmo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Humans (</a:t>
                      </a:r>
                      <a:r>
                        <a:rPr lang="en-US" sz="11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Hadza</a:t>
                      </a: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hunter-gathers)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Fin whale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African elephant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Killer whale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hort-finned pilot whale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Chimpanze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978496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1BC5BCA5-9FB2-43B0-901F-9708291789B0}"/>
              </a:ext>
            </a:extLst>
          </p:cNvPr>
          <p:cNvSpPr txBox="1"/>
          <p:nvPr/>
        </p:nvSpPr>
        <p:spPr>
          <a:xfrm>
            <a:off x="2269894" y="372204"/>
            <a:ext cx="5215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</a:t>
            </a:r>
            <a:r>
              <a:rPr lang="en-US" altLang="zh-CN" dirty="0"/>
              <a:t>1</a:t>
            </a:r>
            <a:r>
              <a:rPr lang="en-US" dirty="0"/>
              <a:t>. </a:t>
            </a:r>
            <a:r>
              <a:rPr lang="en-AU" dirty="0"/>
              <a:t>list of species with different lifespan model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0428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</TotalTime>
  <Words>120</Words>
  <Application>Microsoft Office PowerPoint</Application>
  <PresentationFormat>Widescreen</PresentationFormat>
  <Paragraphs>6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anley Yu</dc:creator>
  <cp:lastModifiedBy>Stanley Yu</cp:lastModifiedBy>
  <cp:revision>7</cp:revision>
  <dcterms:created xsi:type="dcterms:W3CDTF">2021-08-04T01:55:06Z</dcterms:created>
  <dcterms:modified xsi:type="dcterms:W3CDTF">2022-12-23T03:48:27Z</dcterms:modified>
</cp:coreProperties>
</file>